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8F4BAC-ED21-4AC2-9EBB-D48BCF0F1C2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AD86D1-A551-48BF-BA84-CD288C3410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A708D4-3581-4C12-8A25-1379CAF2B52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336A2B-4E93-47F5-91DC-45288033C97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2CB411-D44D-4DDF-A501-95C551A86A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C752CE-0401-4A03-A6DE-E344AB902B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E87DD3-0AEE-4A77-A8B8-F6D089652F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7FF587-6396-405C-9178-78D38EAA2E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0C57B3-232C-4F84-B255-C6D7D98997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6CCDB9-9ABE-4317-B0A7-6C26C9F578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605ED5-E82D-4E00-8F21-24E5F36222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DD8E3C-2B72-499A-AAD3-2051496A02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864AC18-6E47-4E49-A6AB-85AA7B55CF39}" type="slidenum">
              <a:rPr b="0" lang="en-AU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2240280" y="907920"/>
            <a:ext cx="4779720" cy="2037240"/>
            <a:chOff x="2240280" y="907920"/>
            <a:chExt cx="4779720" cy="2037240"/>
          </a:xfrm>
        </p:grpSpPr>
        <p:pic>
          <p:nvPicPr>
            <p:cNvPr id="42" name="Picture 2" descr=""/>
            <p:cNvPicPr/>
            <p:nvPr/>
          </p:nvPicPr>
          <p:blipFill>
            <a:blip r:embed="rId1"/>
            <a:srcRect l="74506" t="0" r="1252" b="-10163"/>
            <a:stretch/>
          </p:blipFill>
          <p:spPr>
            <a:xfrm>
              <a:off x="3383640" y="1308960"/>
              <a:ext cx="2279520" cy="902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2" descr=""/>
            <p:cNvPicPr/>
            <p:nvPr/>
          </p:nvPicPr>
          <p:blipFill>
            <a:blip r:embed="rId2"/>
            <a:srcRect l="5956" t="13058" r="0" b="8866"/>
            <a:stretch/>
          </p:blipFill>
          <p:spPr>
            <a:xfrm>
              <a:off x="3305160" y="907920"/>
              <a:ext cx="2338560" cy="601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 Box 28"/>
            <p:cNvSpPr/>
            <p:nvPr/>
          </p:nvSpPr>
          <p:spPr>
            <a:xfrm>
              <a:off x="2257920" y="1585800"/>
              <a:ext cx="1036080" cy="4010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-Acti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82"/>
            <p:cNvSpPr/>
            <p:nvPr/>
          </p:nvSpPr>
          <p:spPr>
            <a:xfrm rot="18035400">
              <a:off x="4066920" y="2110680"/>
              <a:ext cx="771120" cy="5191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D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83"/>
            <p:cNvSpPr/>
            <p:nvPr/>
          </p:nvSpPr>
          <p:spPr>
            <a:xfrm rot="17695200">
              <a:off x="4890240" y="2067480"/>
              <a:ext cx="675360" cy="504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81"/>
            <p:cNvSpPr/>
            <p:nvPr/>
          </p:nvSpPr>
          <p:spPr>
            <a:xfrm rot="18070800">
              <a:off x="3208320" y="2158560"/>
              <a:ext cx="927720" cy="5133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27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25"/>
            <p:cNvSpPr/>
            <p:nvPr/>
          </p:nvSpPr>
          <p:spPr>
            <a:xfrm>
              <a:off x="5843520" y="1032480"/>
              <a:ext cx="1153440" cy="5014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92 kD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30"/>
            <p:cNvSpPr/>
            <p:nvPr/>
          </p:nvSpPr>
          <p:spPr>
            <a:xfrm flipH="1">
              <a:off x="5697000" y="1227600"/>
              <a:ext cx="208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30"/>
            <p:cNvSpPr/>
            <p:nvPr/>
          </p:nvSpPr>
          <p:spPr>
            <a:xfrm flipH="1">
              <a:off x="5676120" y="1767240"/>
              <a:ext cx="208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25"/>
            <p:cNvSpPr/>
            <p:nvPr/>
          </p:nvSpPr>
          <p:spPr>
            <a:xfrm>
              <a:off x="5866560" y="1585800"/>
              <a:ext cx="1153440" cy="5014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42 kD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2"/>
            <p:cNvSpPr/>
            <p:nvPr/>
          </p:nvSpPr>
          <p:spPr>
            <a:xfrm>
              <a:off x="2240280" y="1008000"/>
              <a:ext cx="846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-Caten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" name="Rectangle 13"/>
          <p:cNvSpPr/>
          <p:nvPr/>
        </p:nvSpPr>
        <p:spPr>
          <a:xfrm>
            <a:off x="468360" y="-243000"/>
            <a:ext cx="28796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 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 3.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Group 14"/>
          <p:cNvGrpSpPr/>
          <p:nvPr/>
        </p:nvGrpSpPr>
        <p:grpSpPr>
          <a:xfrm>
            <a:off x="2484360" y="3068640"/>
            <a:ext cx="4052880" cy="1436400"/>
            <a:chOff x="2484360" y="3068640"/>
            <a:chExt cx="4052880" cy="1436400"/>
          </a:xfrm>
        </p:grpSpPr>
        <p:grpSp>
          <p:nvGrpSpPr>
            <p:cNvPr id="55" name="Group 13"/>
            <p:cNvGrpSpPr/>
            <p:nvPr/>
          </p:nvGrpSpPr>
          <p:grpSpPr>
            <a:xfrm>
              <a:off x="2484360" y="3068640"/>
              <a:ext cx="4052880" cy="1436400"/>
              <a:chOff x="2484360" y="3068640"/>
              <a:chExt cx="4052880" cy="1436400"/>
            </a:xfrm>
          </p:grpSpPr>
          <p:pic>
            <p:nvPicPr>
              <p:cNvPr id="56" name="Picture 20" descr=""/>
              <p:cNvPicPr/>
              <p:nvPr/>
            </p:nvPicPr>
            <p:blipFill>
              <a:blip r:embed="rId3"/>
              <a:srcRect l="60868" t="33447" r="27480" b="20034"/>
              <a:stretch/>
            </p:blipFill>
            <p:spPr>
              <a:xfrm>
                <a:off x="3553920" y="3664800"/>
                <a:ext cx="929160" cy="5338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7" name="Picture 22" descr=""/>
              <p:cNvPicPr/>
              <p:nvPr/>
            </p:nvPicPr>
            <p:blipFill>
              <a:blip r:embed="rId4"/>
              <a:srcRect l="24739" t="29032" r="64687" b="22241"/>
              <a:stretch/>
            </p:blipFill>
            <p:spPr>
              <a:xfrm>
                <a:off x="4712760" y="3572640"/>
                <a:ext cx="926280" cy="640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8" name="Rectangle 21"/>
              <p:cNvSpPr/>
              <p:nvPr/>
            </p:nvSpPr>
            <p:spPr>
              <a:xfrm>
                <a:off x="2484360" y="3233880"/>
                <a:ext cx="1128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-Caten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9" name="Group 35"/>
              <p:cNvGrpSpPr/>
              <p:nvPr/>
            </p:nvGrpSpPr>
            <p:grpSpPr>
              <a:xfrm>
                <a:off x="5475240" y="3243240"/>
                <a:ext cx="873720" cy="533880"/>
                <a:chOff x="5475240" y="3243240"/>
                <a:chExt cx="873720" cy="533880"/>
              </a:xfrm>
            </p:grpSpPr>
            <p:sp>
              <p:nvSpPr>
                <p:cNvPr id="60" name="Text Box 25"/>
                <p:cNvSpPr/>
                <p:nvPr/>
              </p:nvSpPr>
              <p:spPr>
                <a:xfrm>
                  <a:off x="5684040" y="3243240"/>
                  <a:ext cx="664920" cy="53388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ffffff"/>
                  </a:solidFill>
                  <a:prstDash val="dash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spcAft>
                      <a:spcPts val="1001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AU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92 kDa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Line 30"/>
                <p:cNvSpPr/>
                <p:nvPr/>
              </p:nvSpPr>
              <p:spPr>
                <a:xfrm flipH="1">
                  <a:off x="5475240" y="3395160"/>
                  <a:ext cx="2412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2" name="Text Box 28"/>
              <p:cNvSpPr/>
              <p:nvPr/>
            </p:nvSpPr>
            <p:spPr>
              <a:xfrm>
                <a:off x="2640960" y="3794400"/>
                <a:ext cx="852840" cy="4618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ffffff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-Actin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Text Box 25"/>
              <p:cNvSpPr/>
              <p:nvPr/>
            </p:nvSpPr>
            <p:spPr>
              <a:xfrm>
                <a:off x="5755680" y="3753360"/>
                <a:ext cx="781560" cy="42696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ffffff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2 kD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Rectangle 27"/>
              <p:cNvSpPr/>
              <p:nvPr/>
            </p:nvSpPr>
            <p:spPr>
              <a:xfrm>
                <a:off x="3366000" y="4046040"/>
                <a:ext cx="136548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mpty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ecto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Rectangle 28"/>
              <p:cNvSpPr/>
              <p:nvPr/>
            </p:nvSpPr>
            <p:spPr>
              <a:xfrm>
                <a:off x="4586040" y="4086360"/>
                <a:ext cx="1253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AU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iRN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6" name="Picture 43" descr="bcat unsil.png"/>
              <p:cNvPicPr/>
              <p:nvPr/>
            </p:nvPicPr>
            <p:blipFill>
              <a:blip r:embed="rId5"/>
              <a:srcRect l="34206" t="6674" r="37014" b="12199"/>
              <a:stretch/>
            </p:blipFill>
            <p:spPr>
              <a:xfrm>
                <a:off x="4599360" y="3068640"/>
                <a:ext cx="838440" cy="638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7" name="Line 30"/>
              <p:cNvSpPr/>
              <p:nvPr/>
            </p:nvSpPr>
            <p:spPr>
              <a:xfrm flipH="1">
                <a:off x="5556960" y="3891960"/>
                <a:ext cx="2412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68" name="Picture 5" descr=""/>
            <p:cNvPicPr/>
            <p:nvPr/>
          </p:nvPicPr>
          <p:blipFill>
            <a:blip r:embed="rId6">
              <a:lum contrast="10000"/>
            </a:blip>
            <a:stretch/>
          </p:blipFill>
          <p:spPr>
            <a:xfrm>
              <a:off x="3684600" y="3140640"/>
              <a:ext cx="720000" cy="4449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9" name="Textfeld 36"/>
          <p:cNvSpPr/>
          <p:nvPr/>
        </p:nvSpPr>
        <p:spPr>
          <a:xfrm>
            <a:off x="468360" y="4941720"/>
            <a:ext cx="800100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presentative images cut from Western blots demonstrating (A)  β-catenin protein expression across the three cell lines; (B) β-catenin protein expression in chemosensitive A2780 cells following siRNA treatment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153"/>
          <p:cNvSpPr/>
          <p:nvPr/>
        </p:nvSpPr>
        <p:spPr>
          <a:xfrm>
            <a:off x="1619280" y="692280"/>
            <a:ext cx="342720" cy="35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153"/>
          <p:cNvSpPr/>
          <p:nvPr/>
        </p:nvSpPr>
        <p:spPr>
          <a:xfrm>
            <a:off x="2195640" y="2997360"/>
            <a:ext cx="342720" cy="35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27T04:24:47Z</dcterms:created>
  <dc:creator>farfuso</dc:creator>
  <dc:description/>
  <dc:language>en-US</dc:language>
  <cp:lastModifiedBy>arfuso</cp:lastModifiedBy>
  <dcterms:modified xsi:type="dcterms:W3CDTF">2012-09-06T11:15:07Z</dcterms:modified>
  <cp:revision>2</cp:revision>
  <dc:subject/>
  <dc:title>Slide 1</dc:title>
</cp:coreProperties>
</file>